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2" r:id="rId3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0" d="100"/>
          <a:sy n="60" d="100"/>
        </p:scale>
        <p:origin x="-1291" y="51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150.26.63.54\sgt-share2\Tilling\Amplicon_seq_2014\Plan03272014-paper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82362486947195"/>
          <c:y val="0.14347455407981191"/>
          <c:w val="0.86153479806959621"/>
          <c:h val="0.71899962460101441"/>
        </c:manualLayout>
      </c:layout>
      <c:barChart>
        <c:barDir val="col"/>
        <c:grouping val="clustered"/>
        <c:varyColors val="0"/>
        <c:ser>
          <c:idx val="1"/>
          <c:order val="0"/>
          <c:tx>
            <c:strRef>
              <c:f>'[Plan03272014-paper.xlsx]Miseq_run'!$AB$3</c:f>
              <c:strCache>
                <c:ptCount val="1"/>
                <c:pt idx="0">
                  <c:v>Read coverage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accent1"/>
              </a:solidFill>
            </a:ln>
          </c:spPr>
          <c:invertIfNegative val="0"/>
          <c:cat>
            <c:strRef>
              <c:f>'[Plan03272014-paper.xlsx]Miseq_run'!$AA$4:$AA$99</c:f>
              <c:strCache>
                <c:ptCount val="96"/>
                <c:pt idx="0">
                  <c:v>A01</c:v>
                </c:pt>
                <c:pt idx="1">
                  <c:v>B01</c:v>
                </c:pt>
                <c:pt idx="2">
                  <c:v>C01</c:v>
                </c:pt>
                <c:pt idx="3">
                  <c:v>D01</c:v>
                </c:pt>
                <c:pt idx="4">
                  <c:v>E01</c:v>
                </c:pt>
                <c:pt idx="5">
                  <c:v>F01</c:v>
                </c:pt>
                <c:pt idx="6">
                  <c:v>G01</c:v>
                </c:pt>
                <c:pt idx="7">
                  <c:v>H01</c:v>
                </c:pt>
                <c:pt idx="8">
                  <c:v>A02</c:v>
                </c:pt>
                <c:pt idx="9">
                  <c:v>B02</c:v>
                </c:pt>
                <c:pt idx="10">
                  <c:v>C02</c:v>
                </c:pt>
                <c:pt idx="11">
                  <c:v>D02</c:v>
                </c:pt>
                <c:pt idx="12">
                  <c:v>E02</c:v>
                </c:pt>
                <c:pt idx="13">
                  <c:v>F02</c:v>
                </c:pt>
                <c:pt idx="14">
                  <c:v>G02</c:v>
                </c:pt>
                <c:pt idx="15">
                  <c:v>H02</c:v>
                </c:pt>
                <c:pt idx="16">
                  <c:v>A03</c:v>
                </c:pt>
                <c:pt idx="17">
                  <c:v>B03</c:v>
                </c:pt>
                <c:pt idx="18">
                  <c:v>C03</c:v>
                </c:pt>
                <c:pt idx="19">
                  <c:v>D03</c:v>
                </c:pt>
                <c:pt idx="20">
                  <c:v>E03</c:v>
                </c:pt>
                <c:pt idx="21">
                  <c:v>F03</c:v>
                </c:pt>
                <c:pt idx="22">
                  <c:v>G03</c:v>
                </c:pt>
                <c:pt idx="23">
                  <c:v>H03</c:v>
                </c:pt>
                <c:pt idx="24">
                  <c:v>A04</c:v>
                </c:pt>
                <c:pt idx="25">
                  <c:v>B04</c:v>
                </c:pt>
                <c:pt idx="26">
                  <c:v>C04</c:v>
                </c:pt>
                <c:pt idx="27">
                  <c:v>D04</c:v>
                </c:pt>
                <c:pt idx="28">
                  <c:v>E04</c:v>
                </c:pt>
                <c:pt idx="29">
                  <c:v>F04</c:v>
                </c:pt>
                <c:pt idx="30">
                  <c:v>G04</c:v>
                </c:pt>
                <c:pt idx="31">
                  <c:v>H04</c:v>
                </c:pt>
                <c:pt idx="32">
                  <c:v>A05</c:v>
                </c:pt>
                <c:pt idx="33">
                  <c:v>B05</c:v>
                </c:pt>
                <c:pt idx="34">
                  <c:v>C05</c:v>
                </c:pt>
                <c:pt idx="35">
                  <c:v>D05</c:v>
                </c:pt>
                <c:pt idx="36">
                  <c:v>E05</c:v>
                </c:pt>
                <c:pt idx="37">
                  <c:v>F05</c:v>
                </c:pt>
                <c:pt idx="38">
                  <c:v>G05</c:v>
                </c:pt>
                <c:pt idx="39">
                  <c:v>H05</c:v>
                </c:pt>
                <c:pt idx="40">
                  <c:v>A06</c:v>
                </c:pt>
                <c:pt idx="41">
                  <c:v>B06</c:v>
                </c:pt>
                <c:pt idx="42">
                  <c:v>C06</c:v>
                </c:pt>
                <c:pt idx="43">
                  <c:v>D06</c:v>
                </c:pt>
                <c:pt idx="44">
                  <c:v>E06</c:v>
                </c:pt>
                <c:pt idx="45">
                  <c:v>F06</c:v>
                </c:pt>
                <c:pt idx="46">
                  <c:v>G06</c:v>
                </c:pt>
                <c:pt idx="47">
                  <c:v>H06</c:v>
                </c:pt>
                <c:pt idx="48">
                  <c:v>A07</c:v>
                </c:pt>
                <c:pt idx="49">
                  <c:v>B07</c:v>
                </c:pt>
                <c:pt idx="50">
                  <c:v>C07</c:v>
                </c:pt>
                <c:pt idx="51">
                  <c:v>D07</c:v>
                </c:pt>
                <c:pt idx="52">
                  <c:v>E07</c:v>
                </c:pt>
                <c:pt idx="53">
                  <c:v>F07</c:v>
                </c:pt>
                <c:pt idx="54">
                  <c:v>G07</c:v>
                </c:pt>
                <c:pt idx="55">
                  <c:v>H07</c:v>
                </c:pt>
                <c:pt idx="56">
                  <c:v>A08</c:v>
                </c:pt>
                <c:pt idx="57">
                  <c:v>B08</c:v>
                </c:pt>
                <c:pt idx="58">
                  <c:v>C08</c:v>
                </c:pt>
                <c:pt idx="59">
                  <c:v>D08</c:v>
                </c:pt>
                <c:pt idx="60">
                  <c:v>E08</c:v>
                </c:pt>
                <c:pt idx="61">
                  <c:v>F08</c:v>
                </c:pt>
                <c:pt idx="62">
                  <c:v>G08</c:v>
                </c:pt>
                <c:pt idx="63">
                  <c:v>H08</c:v>
                </c:pt>
                <c:pt idx="64">
                  <c:v>A09</c:v>
                </c:pt>
                <c:pt idx="65">
                  <c:v>B09</c:v>
                </c:pt>
                <c:pt idx="66">
                  <c:v>C09</c:v>
                </c:pt>
                <c:pt idx="67">
                  <c:v>D09</c:v>
                </c:pt>
                <c:pt idx="68">
                  <c:v>E09</c:v>
                </c:pt>
                <c:pt idx="69">
                  <c:v>F09</c:v>
                </c:pt>
                <c:pt idx="70">
                  <c:v>G09</c:v>
                </c:pt>
                <c:pt idx="71">
                  <c:v>H09</c:v>
                </c:pt>
                <c:pt idx="72">
                  <c:v>A10</c:v>
                </c:pt>
                <c:pt idx="73">
                  <c:v>B10</c:v>
                </c:pt>
                <c:pt idx="74">
                  <c:v>C10</c:v>
                </c:pt>
                <c:pt idx="75">
                  <c:v>D10</c:v>
                </c:pt>
                <c:pt idx="76">
                  <c:v>E10</c:v>
                </c:pt>
                <c:pt idx="77">
                  <c:v>F10</c:v>
                </c:pt>
                <c:pt idx="78">
                  <c:v>G10</c:v>
                </c:pt>
                <c:pt idx="79">
                  <c:v>H10</c:v>
                </c:pt>
                <c:pt idx="80">
                  <c:v>A11</c:v>
                </c:pt>
                <c:pt idx="81">
                  <c:v>B11</c:v>
                </c:pt>
                <c:pt idx="82">
                  <c:v>C11</c:v>
                </c:pt>
                <c:pt idx="83">
                  <c:v>D11</c:v>
                </c:pt>
                <c:pt idx="84">
                  <c:v>E11</c:v>
                </c:pt>
                <c:pt idx="85">
                  <c:v>F11</c:v>
                </c:pt>
                <c:pt idx="86">
                  <c:v>G11</c:v>
                </c:pt>
                <c:pt idx="87">
                  <c:v>H11</c:v>
                </c:pt>
                <c:pt idx="88">
                  <c:v>A12</c:v>
                </c:pt>
                <c:pt idx="89">
                  <c:v>B12</c:v>
                </c:pt>
                <c:pt idx="90">
                  <c:v>C12</c:v>
                </c:pt>
                <c:pt idx="91">
                  <c:v>D12</c:v>
                </c:pt>
                <c:pt idx="92">
                  <c:v>E12</c:v>
                </c:pt>
                <c:pt idx="93">
                  <c:v>F12</c:v>
                </c:pt>
                <c:pt idx="94">
                  <c:v>G12</c:v>
                </c:pt>
                <c:pt idx="95">
                  <c:v>H12</c:v>
                </c:pt>
              </c:strCache>
            </c:strRef>
          </c:cat>
          <c:val>
            <c:numRef>
              <c:f>'[Plan03272014-paper.xlsx]Miseq_run'!$AB$4:$AB$99</c:f>
              <c:numCache>
                <c:formatCode>0_ </c:formatCode>
                <c:ptCount val="96"/>
                <c:pt idx="0">
                  <c:v>983.61197925270073</c:v>
                </c:pt>
                <c:pt idx="1">
                  <c:v>1485.9514354620239</c:v>
                </c:pt>
                <c:pt idx="2">
                  <c:v>1531.3929763123988</c:v>
                </c:pt>
                <c:pt idx="3">
                  <c:v>1593.9243120023787</c:v>
                </c:pt>
                <c:pt idx="4">
                  <c:v>1576.4270706002842</c:v>
                </c:pt>
                <c:pt idx="5">
                  <c:v>1559.7721100796193</c:v>
                </c:pt>
                <c:pt idx="6">
                  <c:v>1326.6012752320855</c:v>
                </c:pt>
                <c:pt idx="7">
                  <c:v>1072.2386269780964</c:v>
                </c:pt>
                <c:pt idx="8">
                  <c:v>1041.854075126367</c:v>
                </c:pt>
                <c:pt idx="9">
                  <c:v>1268.2325811886749</c:v>
                </c:pt>
                <c:pt idx="10">
                  <c:v>1336.7431035052364</c:v>
                </c:pt>
                <c:pt idx="11">
                  <c:v>1173.2170867884633</c:v>
                </c:pt>
                <c:pt idx="12">
                  <c:v>1373.9825233737488</c:v>
                </c:pt>
                <c:pt idx="13">
                  <c:v>1320.9919059103372</c:v>
                </c:pt>
                <c:pt idx="14">
                  <c:v>1390.6897816247647</c:v>
                </c:pt>
                <c:pt idx="15">
                  <c:v>1375.3745416102283</c:v>
                </c:pt>
                <c:pt idx="16">
                  <c:v>1075.7325977072253</c:v>
                </c:pt>
                <c:pt idx="17">
                  <c:v>1344.3953219465459</c:v>
                </c:pt>
                <c:pt idx="18">
                  <c:v>1310.9913112425254</c:v>
                </c:pt>
                <c:pt idx="19">
                  <c:v>1280.9905513892102</c:v>
                </c:pt>
                <c:pt idx="20">
                  <c:v>1281.4862070104728</c:v>
                </c:pt>
                <c:pt idx="21">
                  <c:v>1302.4679044567049</c:v>
                </c:pt>
                <c:pt idx="22">
                  <c:v>1467.1609897915359</c:v>
                </c:pt>
                <c:pt idx="23">
                  <c:v>1180.0437080841784</c:v>
                </c:pt>
                <c:pt idx="24">
                  <c:v>889.98628960322446</c:v>
                </c:pt>
                <c:pt idx="25">
                  <c:v>1462.55522151376</c:v>
                </c:pt>
                <c:pt idx="26">
                  <c:v>1512.9768079553339</c:v>
                </c:pt>
                <c:pt idx="27">
                  <c:v>1439.7650071029766</c:v>
                </c:pt>
                <c:pt idx="28">
                  <c:v>1238.3721959760812</c:v>
                </c:pt>
                <c:pt idx="29">
                  <c:v>1382.1375334500644</c:v>
                </c:pt>
                <c:pt idx="30">
                  <c:v>884.91836532425918</c:v>
                </c:pt>
                <c:pt idx="31">
                  <c:v>1485.8517955664211</c:v>
                </c:pt>
                <c:pt idx="32">
                  <c:v>1085.5625557501073</c:v>
                </c:pt>
                <c:pt idx="33">
                  <c:v>1562.3932406092042</c:v>
                </c:pt>
                <c:pt idx="34">
                  <c:v>1475.8587003204598</c:v>
                </c:pt>
                <c:pt idx="35">
                  <c:v>1417.5977732994152</c:v>
                </c:pt>
                <c:pt idx="36">
                  <c:v>1553.0607552281213</c:v>
                </c:pt>
                <c:pt idx="37">
                  <c:v>1620.3728567180945</c:v>
                </c:pt>
                <c:pt idx="38">
                  <c:v>1550.5207307806668</c:v>
                </c:pt>
                <c:pt idx="39">
                  <c:v>1470.18457828141</c:v>
                </c:pt>
                <c:pt idx="40">
                  <c:v>1135.0737718457829</c:v>
                </c:pt>
                <c:pt idx="41">
                  <c:v>1238.9468102679309</c:v>
                </c:pt>
                <c:pt idx="42">
                  <c:v>1501.1615514222472</c:v>
                </c:pt>
                <c:pt idx="43">
                  <c:v>1175.5213584855794</c:v>
                </c:pt>
                <c:pt idx="44">
                  <c:v>1383.1015230103405</c:v>
                </c:pt>
                <c:pt idx="45">
                  <c:v>1462.3006376160429</c:v>
                </c:pt>
                <c:pt idx="46">
                  <c:v>1562.542039710595</c:v>
                </c:pt>
                <c:pt idx="47">
                  <c:v>1370.7025009085203</c:v>
                </c:pt>
                <c:pt idx="48">
                  <c:v>1144.0119594304404</c:v>
                </c:pt>
                <c:pt idx="49">
                  <c:v>1384.3449073309325</c:v>
                </c:pt>
                <c:pt idx="50">
                  <c:v>1504.0397766691995</c:v>
                </c:pt>
                <c:pt idx="51">
                  <c:v>1160.0829231226667</c:v>
                </c:pt>
                <c:pt idx="52">
                  <c:v>1470.0330040635633</c:v>
                </c:pt>
                <c:pt idx="53">
                  <c:v>1330.7969870164195</c:v>
                </c:pt>
                <c:pt idx="54">
                  <c:v>1417.7532789322408</c:v>
                </c:pt>
                <c:pt idx="55">
                  <c:v>1358.4862070104728</c:v>
                </c:pt>
                <c:pt idx="56">
                  <c:v>1064.8564868347155</c:v>
                </c:pt>
                <c:pt idx="57">
                  <c:v>1036.1263669100399</c:v>
                </c:pt>
                <c:pt idx="58">
                  <c:v>1216.6880306584294</c:v>
                </c:pt>
                <c:pt idx="59">
                  <c:v>1419.7777924609336</c:v>
                </c:pt>
                <c:pt idx="60">
                  <c:v>1449.0080280154614</c:v>
                </c:pt>
                <c:pt idx="61">
                  <c:v>1439.9539462816742</c:v>
                </c:pt>
                <c:pt idx="62">
                  <c:v>1226.2430209124848</c:v>
                </c:pt>
                <c:pt idx="63">
                  <c:v>1307.6613036439921</c:v>
                </c:pt>
                <c:pt idx="64">
                  <c:v>1101.188807030295</c:v>
                </c:pt>
                <c:pt idx="65">
                  <c:v>1715.5021969671941</c:v>
                </c:pt>
                <c:pt idx="66">
                  <c:v>1362.940500181704</c:v>
                </c:pt>
                <c:pt idx="67">
                  <c:v>1721.6487825828406</c:v>
                </c:pt>
                <c:pt idx="68">
                  <c:v>1842.0784300769765</c:v>
                </c:pt>
                <c:pt idx="69">
                  <c:v>1821.2322838547689</c:v>
                </c:pt>
                <c:pt idx="70">
                  <c:v>1717.8109947471009</c:v>
                </c:pt>
                <c:pt idx="71">
                  <c:v>2212.2781393504906</c:v>
                </c:pt>
                <c:pt idx="72">
                  <c:v>1096.970002312597</c:v>
                </c:pt>
                <c:pt idx="73">
                  <c:v>1248.6440252403449</c:v>
                </c:pt>
                <c:pt idx="74">
                  <c:v>1352.5871683901021</c:v>
                </c:pt>
                <c:pt idx="75">
                  <c:v>1634.0458885328223</c:v>
                </c:pt>
                <c:pt idx="76">
                  <c:v>1386.4303082361491</c:v>
                </c:pt>
                <c:pt idx="77">
                  <c:v>1385.906868413228</c:v>
                </c:pt>
                <c:pt idx="78">
                  <c:v>1433.4138557600186</c:v>
                </c:pt>
                <c:pt idx="79">
                  <c:v>1213.7863490700056</c:v>
                </c:pt>
                <c:pt idx="80">
                  <c:v>1034.4789718854274</c:v>
                </c:pt>
                <c:pt idx="81">
                  <c:v>1483.0808748224256</c:v>
                </c:pt>
                <c:pt idx="82">
                  <c:v>1473.3940004625194</c:v>
                </c:pt>
                <c:pt idx="83">
                  <c:v>1649.6174964485117</c:v>
                </c:pt>
                <c:pt idx="84">
                  <c:v>1543.7394363870626</c:v>
                </c:pt>
                <c:pt idx="85">
                  <c:v>1622.3378373913906</c:v>
                </c:pt>
                <c:pt idx="86">
                  <c:v>1522.4542601341307</c:v>
                </c:pt>
                <c:pt idx="87">
                  <c:v>1405.3856090389506</c:v>
                </c:pt>
                <c:pt idx="88">
                  <c:v>870.84290858634245</c:v>
                </c:pt>
                <c:pt idx="89">
                  <c:v>1360.4568370279824</c:v>
                </c:pt>
                <c:pt idx="90">
                  <c:v>1484.0918431398461</c:v>
                </c:pt>
                <c:pt idx="91">
                  <c:v>1589.5747464402525</c:v>
                </c:pt>
                <c:pt idx="92">
                  <c:v>1494.9741649872808</c:v>
                </c:pt>
                <c:pt idx="93">
                  <c:v>1401.0042617859856</c:v>
                </c:pt>
                <c:pt idx="94">
                  <c:v>1750.8928276454458</c:v>
                </c:pt>
                <c:pt idx="95">
                  <c:v>1288.792427896527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2138368"/>
        <c:axId val="52140288"/>
      </c:barChart>
      <c:catAx>
        <c:axId val="52138368"/>
        <c:scaling>
          <c:orientation val="minMax"/>
        </c:scaling>
        <c:delete val="0"/>
        <c:axPos val="b"/>
        <c:title>
          <c:tx>
            <c:strRef>
              <c:f>'[Plan03272014-paper.xlsx]Miseq_run'!$AF$3</c:f>
              <c:strCache>
                <c:ptCount val="1"/>
                <c:pt idx="0">
                  <c:v>Location of sample well</c:v>
                </c:pt>
              </c:strCache>
            </c:strRef>
          </c:tx>
          <c:layout>
            <c:manualLayout>
              <c:xMode val="edge"/>
              <c:yMode val="edge"/>
              <c:x val="0.45448654898304508"/>
              <c:y val="0.92878851177585353"/>
            </c:manualLayout>
          </c:layout>
          <c:overlay val="0"/>
          <c:txPr>
            <a:bodyPr/>
            <a:lstStyle/>
            <a:p>
              <a:pPr>
                <a:defRPr sz="1200">
                  <a:latin typeface="+mn-lt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General" sourceLinked="0"/>
        <c:majorTickMark val="out"/>
        <c:minorTickMark val="none"/>
        <c:tickLblPos val="nextTo"/>
        <c:txPr>
          <a:bodyPr rot="0" vert="horz"/>
          <a:lstStyle/>
          <a:p>
            <a:pPr>
              <a:defRPr>
                <a:latin typeface="+mn-lt"/>
                <a:cs typeface="Times New Roman" panose="02020603050405020304" pitchFamily="18" charset="0"/>
              </a:defRPr>
            </a:pPr>
            <a:endParaRPr lang="ja-JP"/>
          </a:p>
        </c:txPr>
        <c:crossAx val="52140288"/>
        <c:crosses val="autoZero"/>
        <c:auto val="1"/>
        <c:lblAlgn val="ctr"/>
        <c:lblOffset val="100"/>
        <c:tickLblSkip val="4"/>
        <c:tickMarkSkip val="4"/>
        <c:noMultiLvlLbl val="0"/>
      </c:catAx>
      <c:valAx>
        <c:axId val="52140288"/>
        <c:scaling>
          <c:orientation val="minMax"/>
          <c:max val="2500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title>
          <c:tx>
            <c:strRef>
              <c:f>'[Plan03272014-paper.xlsx]Miseq_run'!$AB$3</c:f>
              <c:strCache>
                <c:ptCount val="1"/>
                <c:pt idx="0">
                  <c:v>Read coverage</c:v>
                </c:pt>
              </c:strCache>
            </c:strRef>
          </c:tx>
          <c:layout>
            <c:manualLayout>
              <c:xMode val="edge"/>
              <c:yMode val="edge"/>
              <c:x val="1.7921146953405017E-2"/>
              <c:y val="3.618697894781716E-2"/>
            </c:manualLayout>
          </c:layout>
          <c:overlay val="0"/>
          <c:txPr>
            <a:bodyPr rot="0" vert="horz"/>
            <a:lstStyle/>
            <a:p>
              <a:pPr>
                <a:defRPr sz="1200">
                  <a:latin typeface="+mn-lt"/>
                  <a:cs typeface="Times New Roman" panose="02020603050405020304" pitchFamily="18" charset="0"/>
                </a:defRPr>
              </a:pPr>
              <a:endParaRPr lang="ja-JP"/>
            </a:p>
          </c:txPr>
        </c:title>
        <c:numFmt formatCode="#,##0_ " sourceLinked="0"/>
        <c:majorTickMark val="out"/>
        <c:minorTickMark val="none"/>
        <c:tickLblPos val="nextTo"/>
        <c:txPr>
          <a:bodyPr/>
          <a:lstStyle/>
          <a:p>
            <a:pPr>
              <a:defRPr>
                <a:latin typeface="+mn-lt"/>
                <a:cs typeface="Times New Roman" panose="02020603050405020304" pitchFamily="18" charset="0"/>
              </a:defRPr>
            </a:pPr>
            <a:endParaRPr lang="ja-JP"/>
          </a:p>
        </c:txPr>
        <c:crossAx val="521383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109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6526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11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6187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14711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0555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294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5661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726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988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15992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90A09-969E-48FF-973E-7E3F0A1ADBA6}" type="datetimeFigureOut">
              <a:rPr kumimoji="1" lang="ja-JP" altLang="en-US" smtClean="0"/>
              <a:t>2015/4/1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2F485-1CFA-4393-868C-F90EFF5DBE2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82036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グループ化 17"/>
          <p:cNvGrpSpPr/>
          <p:nvPr/>
        </p:nvGrpSpPr>
        <p:grpSpPr>
          <a:xfrm>
            <a:off x="0" y="2771800"/>
            <a:ext cx="6858000" cy="6102170"/>
            <a:chOff x="0" y="1"/>
            <a:chExt cx="6858000" cy="6102170"/>
          </a:xfrm>
        </p:grpSpPr>
        <p:sp>
          <p:nvSpPr>
            <p:cNvPr id="4" name="正方形/長方形 3"/>
            <p:cNvSpPr/>
            <p:nvPr/>
          </p:nvSpPr>
          <p:spPr>
            <a:xfrm>
              <a:off x="0" y="5148064"/>
              <a:ext cx="6858000" cy="9541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just"/>
              <a:r>
                <a:rPr kumimoji="0" lang="en-US" altLang="ja-JP" sz="1400" b="1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Figure S2. Structures of seven genes analyzed by indexed </a:t>
              </a:r>
              <a:r>
                <a:rPr kumimoji="0" lang="en-US" altLang="ja-JP" sz="1400" b="1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amplicon </a:t>
              </a:r>
              <a:r>
                <a:rPr kumimoji="0" lang="en-US" altLang="ja-JP" sz="1400" b="1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sequencing.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Coding regions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(yellow), transcripts (green) and primer 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binding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sites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 (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red) shown 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as annotation on the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seven gene sequences. The labels over annotations indicates either name of gene annotation (</a:t>
              </a:r>
              <a:r>
                <a:rPr kumimoji="0" lang="en-US" altLang="ja-JP" sz="1400" kern="0" dirty="0" err="1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Glyma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) or primer name.</a:t>
              </a:r>
            </a:p>
          </p:txBody>
        </p:sp>
        <p:grpSp>
          <p:nvGrpSpPr>
            <p:cNvPr id="12" name="グループ化 11"/>
            <p:cNvGrpSpPr/>
            <p:nvPr/>
          </p:nvGrpSpPr>
          <p:grpSpPr>
            <a:xfrm>
              <a:off x="0" y="1"/>
              <a:ext cx="6351444" cy="5148063"/>
              <a:chOff x="0" y="1"/>
              <a:chExt cx="6858000" cy="5558644"/>
            </a:xfrm>
          </p:grpSpPr>
          <p:pic>
            <p:nvPicPr>
              <p:cNvPr id="2" name="図 1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23506"/>
              <a:stretch/>
            </p:blipFill>
            <p:spPr>
              <a:xfrm>
                <a:off x="0" y="1"/>
                <a:ext cx="6858000" cy="3563888"/>
              </a:xfrm>
              <a:prstGeom prst="rect">
                <a:avLst/>
              </a:prstGeom>
            </p:spPr>
          </p:pic>
          <p:pic>
            <p:nvPicPr>
              <p:cNvPr id="3" name="図 2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60276"/>
              <a:stretch/>
            </p:blipFill>
            <p:spPr>
              <a:xfrm>
                <a:off x="0" y="3707904"/>
                <a:ext cx="6858000" cy="1850741"/>
              </a:xfrm>
              <a:prstGeom prst="rect">
                <a:avLst/>
              </a:prstGeom>
            </p:spPr>
          </p:pic>
          <p:sp>
            <p:nvSpPr>
              <p:cNvPr id="5" name="Rectangle 22"/>
              <p:cNvSpPr>
                <a:spLocks noChangeArrowheads="1"/>
              </p:cNvSpPr>
              <p:nvPr/>
            </p:nvSpPr>
            <p:spPr bwMode="auto">
              <a:xfrm>
                <a:off x="3573016" y="524122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Rectangle 22"/>
              <p:cNvSpPr>
                <a:spLocks noChangeArrowheads="1"/>
              </p:cNvSpPr>
              <p:nvPr/>
            </p:nvSpPr>
            <p:spPr bwMode="auto">
              <a:xfrm>
                <a:off x="2492896" y="46332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7" name="Rectangle 22"/>
              <p:cNvSpPr>
                <a:spLocks noChangeArrowheads="1"/>
              </p:cNvSpPr>
              <p:nvPr/>
            </p:nvSpPr>
            <p:spPr bwMode="auto">
              <a:xfrm>
                <a:off x="5695156" y="402524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8" name="Rectangle 22"/>
              <p:cNvSpPr>
                <a:spLocks noChangeArrowheads="1"/>
              </p:cNvSpPr>
              <p:nvPr/>
            </p:nvSpPr>
            <p:spPr bwMode="auto">
              <a:xfrm>
                <a:off x="5301208" y="3386152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Rectangle 22"/>
              <p:cNvSpPr>
                <a:spLocks noChangeArrowheads="1"/>
              </p:cNvSpPr>
              <p:nvPr/>
            </p:nvSpPr>
            <p:spPr bwMode="auto">
              <a:xfrm>
                <a:off x="6416706" y="284380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10" name="Rectangle 22"/>
              <p:cNvSpPr>
                <a:spLocks noChangeArrowheads="1"/>
              </p:cNvSpPr>
              <p:nvPr/>
            </p:nvSpPr>
            <p:spPr bwMode="auto">
              <a:xfrm>
                <a:off x="4293096" y="178194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  <p:sp>
            <p:nvSpPr>
              <p:cNvPr id="11" name="Rectangle 22"/>
              <p:cNvSpPr>
                <a:spLocks noChangeArrowheads="1"/>
              </p:cNvSpPr>
              <p:nvPr/>
            </p:nvSpPr>
            <p:spPr bwMode="auto">
              <a:xfrm>
                <a:off x="6454668" y="117238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hangingPunct="0"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(</a:t>
                </a:r>
                <a:r>
                  <a:rPr kumimoji="0" lang="en-US" altLang="ja-JP" sz="800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bp</a:t>
                </a:r>
                <a:r>
                  <a:rPr kumimoji="0" lang="en-US" altLang="ja-JP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+mn-lt"/>
                    <a:cs typeface="Times New Roman" panose="02020603050405020304" pitchFamily="18" charset="0"/>
                  </a:rPr>
                  <a:t>)</a:t>
                </a:r>
                <a:endParaRPr kumimoji="0" lang="ja-JP" altLang="ja-JP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+mn-lt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7" name="グループ化 16"/>
          <p:cNvGrpSpPr/>
          <p:nvPr/>
        </p:nvGrpSpPr>
        <p:grpSpPr>
          <a:xfrm>
            <a:off x="0" y="237585"/>
            <a:ext cx="6858000" cy="2174175"/>
            <a:chOff x="12509" y="6516216"/>
            <a:chExt cx="6858000" cy="2174175"/>
          </a:xfrm>
        </p:grpSpPr>
        <p:sp>
          <p:nvSpPr>
            <p:cNvPr id="14" name="正方形/長方形 13"/>
            <p:cNvSpPr/>
            <p:nvPr/>
          </p:nvSpPr>
          <p:spPr>
            <a:xfrm>
              <a:off x="12509" y="7520840"/>
              <a:ext cx="6858000" cy="116955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just"/>
              <a:r>
                <a:rPr kumimoji="0" lang="en-US" altLang="ja-JP" sz="1400" b="1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Figure S1. </a:t>
              </a:r>
              <a:r>
                <a:rPr kumimoji="0" lang="en-US" altLang="ja-JP" sz="1400" b="1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Comparison </a:t>
              </a:r>
              <a:r>
                <a:rPr kumimoji="0" lang="en-US" altLang="ja-JP" sz="1400" b="1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of scanning regions of HRM analysis and indexed amplicon sequencing analysis in </a:t>
              </a:r>
              <a:r>
                <a:rPr kumimoji="0" lang="en-US" altLang="ja-JP" sz="1400" b="1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Glyma20g25000</a:t>
              </a:r>
              <a:r>
                <a:rPr kumimoji="0" lang="en-US" altLang="ja-JP" sz="1400" b="1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.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Coding regions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(yellow), transcripts (green), scanning regions by HRM 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analysis (red) indexed amplicon sequencing analysis (purple)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shown </a:t>
              </a:r>
              <a:r>
                <a:rPr kumimoji="0" lang="en-US" altLang="ja-JP" sz="1400" kern="0" dirty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as 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annotation. The labels over annotations indicates either name of gene annotation (</a:t>
              </a:r>
              <a:r>
                <a:rPr kumimoji="0" lang="en-US" altLang="ja-JP" sz="1400" kern="0" dirty="0" err="1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Glyma</a:t>
              </a:r>
              <a:r>
                <a:rPr kumimoji="0" lang="en-US" altLang="ja-JP" sz="1400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) or amplicon in Table 3.</a:t>
              </a:r>
            </a:p>
          </p:txBody>
        </p:sp>
        <p:pic>
          <p:nvPicPr>
            <p:cNvPr id="15" name="図 14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365"/>
            <a:stretch/>
          </p:blipFill>
          <p:spPr>
            <a:xfrm>
              <a:off x="12509" y="6516216"/>
              <a:ext cx="6858000" cy="99798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8797512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グループ化 2"/>
          <p:cNvGrpSpPr/>
          <p:nvPr/>
        </p:nvGrpSpPr>
        <p:grpSpPr>
          <a:xfrm>
            <a:off x="0" y="2509900"/>
            <a:ext cx="6858000" cy="4124201"/>
            <a:chOff x="0" y="323528"/>
            <a:chExt cx="6858000" cy="4124201"/>
          </a:xfrm>
        </p:grpSpPr>
        <p:graphicFrame>
          <p:nvGraphicFramePr>
            <p:cNvPr id="2" name="グラフ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59708741"/>
                </p:ext>
              </p:extLst>
            </p:nvPr>
          </p:nvGraphicFramePr>
          <p:xfrm>
            <a:off x="92630" y="323528"/>
            <a:ext cx="6672741" cy="3912012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4" name="正方形/長方形 3"/>
            <p:cNvSpPr/>
            <p:nvPr/>
          </p:nvSpPr>
          <p:spPr>
            <a:xfrm>
              <a:off x="0" y="4139952"/>
              <a:ext cx="685800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just"/>
              <a:r>
                <a:rPr kumimoji="0" lang="en-US" altLang="ja-JP" sz="1400" b="1" kern="0" dirty="0" smtClean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Times New Roman Bold"/>
                  <a:cs typeface="Times New Roman" panose="02020603050405020304" pitchFamily="18" charset="0"/>
                  <a:sym typeface="Times New Roman Bold"/>
                </a:rPr>
                <a:t>Figure S3. Variation of read coverage by the sample well location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859184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54</Words>
  <Application>Microsoft Office PowerPoint</Application>
  <PresentationFormat>画面に合わせる (4:3)</PresentationFormat>
  <Paragraphs>10</Paragraphs>
  <Slides>2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3" baseType="lpstr">
      <vt:lpstr>Office ​​テーマ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Tsuda</dc:creator>
  <cp:lastModifiedBy>MTsuda</cp:lastModifiedBy>
  <cp:revision>8</cp:revision>
  <dcterms:created xsi:type="dcterms:W3CDTF">2015-01-26T05:55:21Z</dcterms:created>
  <dcterms:modified xsi:type="dcterms:W3CDTF">2015-04-10T10:12:42Z</dcterms:modified>
</cp:coreProperties>
</file>